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6" r:id="rId2"/>
  </p:sldIdLst>
  <p:sldSz cx="6119813" cy="6840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53" userDrawn="1">
          <p15:clr>
            <a:srgbClr val="A4A3A4"/>
          </p15:clr>
        </p15:guide>
        <p15:guide id="2" pos="190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3710" autoAdjust="0"/>
    <p:restoredTop sz="94660"/>
  </p:normalViewPr>
  <p:slideViewPr>
    <p:cSldViewPr snapToGrid="0">
      <p:cViewPr>
        <p:scale>
          <a:sx n="213" d="100"/>
          <a:sy n="213" d="100"/>
        </p:scale>
        <p:origin x="245" y="-4632"/>
      </p:cViewPr>
      <p:guideLst>
        <p:guide orient="horz" pos="2153"/>
        <p:guide pos="1906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119505"/>
            <a:ext cx="5201841" cy="2381521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3592866"/>
            <a:ext cx="4589860" cy="1651546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D6502-A9D7-4D9E-B890-9D228E1CCD8E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90F7-40DB-4B83-8231-78D198EC1E5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83652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D6502-A9D7-4D9E-B890-9D228E1CCD8E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90F7-40DB-4B83-8231-78D198EC1E5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976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364195"/>
            <a:ext cx="1319585" cy="5797040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364195"/>
            <a:ext cx="3882256" cy="5797040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D6502-A9D7-4D9E-B890-9D228E1CCD8E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90F7-40DB-4B83-8231-78D198EC1E5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6692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D6502-A9D7-4D9E-B890-9D228E1CCD8E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90F7-40DB-4B83-8231-78D198EC1E5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43935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1705386"/>
            <a:ext cx="5278339" cy="2845473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4577779"/>
            <a:ext cx="5278339" cy="1496367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D6502-A9D7-4D9E-B890-9D228E1CCD8E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90F7-40DB-4B83-8231-78D198EC1E5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6279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1820976"/>
            <a:ext cx="2600921" cy="4340259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1820976"/>
            <a:ext cx="2600921" cy="4340259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D6502-A9D7-4D9E-B890-9D228E1CCD8E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90F7-40DB-4B83-8231-78D198EC1E5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4710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364197"/>
            <a:ext cx="5278339" cy="1322188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676882"/>
            <a:ext cx="2588967" cy="82181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2498697"/>
            <a:ext cx="2588967" cy="3675206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676882"/>
            <a:ext cx="2601718" cy="82181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2498697"/>
            <a:ext cx="2601718" cy="3675206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D6502-A9D7-4D9E-B890-9D228E1CCD8E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90F7-40DB-4B83-8231-78D198EC1E5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17952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D6502-A9D7-4D9E-B890-9D228E1CCD8E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90F7-40DB-4B83-8231-78D198EC1E5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08331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D6502-A9D7-4D9E-B890-9D228E1CCD8E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90F7-40DB-4B83-8231-78D198EC1E5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5516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56036"/>
            <a:ext cx="1973799" cy="1596126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984912"/>
            <a:ext cx="3098155" cy="4861216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052161"/>
            <a:ext cx="1973799" cy="3801883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D6502-A9D7-4D9E-B890-9D228E1CCD8E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90F7-40DB-4B83-8231-78D198EC1E5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6143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56036"/>
            <a:ext cx="1973799" cy="1596126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984912"/>
            <a:ext cx="3098155" cy="4861216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052161"/>
            <a:ext cx="1973799" cy="3801883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D6502-A9D7-4D9E-B890-9D228E1CCD8E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90F7-40DB-4B83-8231-78D198EC1E5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0368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364197"/>
            <a:ext cx="5278339" cy="1322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1820976"/>
            <a:ext cx="5278339" cy="434025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6340167"/>
            <a:ext cx="1376958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2D6502-A9D7-4D9E-B890-9D228E1CCD8E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6340167"/>
            <a:ext cx="2065437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6340167"/>
            <a:ext cx="1376958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7790F7-40DB-4B83-8231-78D198EC1E5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08080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Objeto 9">
            <a:extLst>
              <a:ext uri="{FF2B5EF4-FFF2-40B4-BE49-F238E27FC236}">
                <a16:creationId xmlns="" xmlns:a16="http://schemas.microsoft.com/office/drawing/2014/main" id="{310D7ABD-4D69-4672-92EE-7C026016DB7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08584868"/>
              </p:ext>
            </p:extLst>
          </p:nvPr>
        </p:nvGraphicFramePr>
        <p:xfrm>
          <a:off x="165894" y="798505"/>
          <a:ext cx="5784850" cy="2706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8" name="Prism 5" r:id="rId3" imgW="6748200" imgH="3159360" progId="Prism5.Document">
                  <p:embed/>
                </p:oleObj>
              </mc:Choice>
              <mc:Fallback>
                <p:oleObj name="Prism 5" r:id="rId3" imgW="6748200" imgH="3159360" progId="Prism5.Document">
                  <p:embed/>
                  <p:pic>
                    <p:nvPicPr>
                      <p:cNvPr id="6" name="Objeto 5">
                        <a:extLst>
                          <a:ext uri="{FF2B5EF4-FFF2-40B4-BE49-F238E27FC236}">
                            <a16:creationId xmlns="" xmlns:a16="http://schemas.microsoft.com/office/drawing/2014/main" id="{69211430-B0E5-4797-8CB5-8E1F5F1FB3E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5894" y="798505"/>
                        <a:ext cx="5784850" cy="27066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CaixaDeTexto 13">
            <a:extLst>
              <a:ext uri="{FF2B5EF4-FFF2-40B4-BE49-F238E27FC236}">
                <a16:creationId xmlns="" xmlns:a16="http://schemas.microsoft.com/office/drawing/2014/main" id="{ACCA1012-FE22-4B23-AFAF-447CC147096E}"/>
              </a:ext>
            </a:extLst>
          </p:cNvPr>
          <p:cNvSpPr txBox="1"/>
          <p:nvPr/>
        </p:nvSpPr>
        <p:spPr>
          <a:xfrm>
            <a:off x="78726" y="47497"/>
            <a:ext cx="5970850" cy="723275"/>
          </a:xfrm>
          <a:prstGeom prst="rect">
            <a:avLst/>
          </a:prstGeom>
          <a:noFill/>
          <a:ln>
            <a:noFill/>
          </a:ln>
        </p:spPr>
        <p:txBody>
          <a:bodyPr wrap="square" lIns="36000" tIns="0" rIns="36000" bIns="0" rtlCol="0">
            <a:spAutoFit/>
          </a:bodyPr>
          <a:lstStyle/>
          <a:p>
            <a:pPr algn="just"/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mp_034000 expression peak at 5 weeks in adult worms (data obtained from a long-oligonucleotide DNA microarray published by Fitzpatrick et al. [33]. Dotted boxes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cate peaks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gene expression. Data shows the fluorescence intensity mean of the probes 3H2 (contig 1729), 77H20 (contig 7640) and 26M20 (CD077779), letters indicate significant differences between stages (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). 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CaixaDeTexto 15">
            <a:extLst>
              <a:ext uri="{FF2B5EF4-FFF2-40B4-BE49-F238E27FC236}">
                <a16:creationId xmlns="" xmlns:a16="http://schemas.microsoft.com/office/drawing/2014/main" id="{06BD3937-76AF-439A-A948-C1A0B8AC6980}"/>
              </a:ext>
            </a:extLst>
          </p:cNvPr>
          <p:cNvSpPr txBox="1"/>
          <p:nvPr/>
        </p:nvSpPr>
        <p:spPr>
          <a:xfrm>
            <a:off x="78727" y="3642698"/>
            <a:ext cx="5970850" cy="723275"/>
          </a:xfrm>
          <a:prstGeom prst="rect">
            <a:avLst/>
          </a:prstGeom>
          <a:noFill/>
          <a:ln>
            <a:noFill/>
          </a:ln>
        </p:spPr>
        <p:txBody>
          <a:bodyPr wrap="square" lIns="36000" tIns="0" rIns="36000" bIns="0" rtlCol="0">
            <a:spAutoFit/>
          </a:bodyPr>
          <a:lstStyle/>
          <a:p>
            <a:pPr algn="just"/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expression data derived from a gonad-specific and pairing-dependent transcriptome study [34], showing the expression levels of Smp_034000 in the ovary in comparison to the rest of the female body (ovary/female); or in the testes in comparison to the rest of male body (testes/male) in the context of single-sex or bi-sex infections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7" name="Objeto 16">
            <a:extLst>
              <a:ext uri="{FF2B5EF4-FFF2-40B4-BE49-F238E27FC236}">
                <a16:creationId xmlns="" xmlns:a16="http://schemas.microsoft.com/office/drawing/2014/main" id="{F6FCD2F9-A2C7-4F9D-8F57-FBD4A5F1220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59929142"/>
              </p:ext>
            </p:extLst>
          </p:nvPr>
        </p:nvGraphicFramePr>
        <p:xfrm>
          <a:off x="801688" y="4362108"/>
          <a:ext cx="4513262" cy="2416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9" name="Prism 5" r:id="rId5" imgW="4512600" imgH="2415600" progId="Prism5.Document">
                  <p:embed/>
                </p:oleObj>
              </mc:Choice>
              <mc:Fallback>
                <p:oleObj name="Prism 5" r:id="rId5" imgW="4512600" imgH="2415600" progId="Prism5.Document">
                  <p:embed/>
                  <p:pic>
                    <p:nvPicPr>
                      <p:cNvPr id="9" name="Objeto 8">
                        <a:extLst>
                          <a:ext uri="{FF2B5EF4-FFF2-40B4-BE49-F238E27FC236}">
                            <a16:creationId xmlns="" xmlns:a16="http://schemas.microsoft.com/office/drawing/2014/main" id="{065A3276-59F7-4B0E-B693-23F376CE50F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01688" y="4362108"/>
                        <a:ext cx="4513262" cy="2416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5325566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8</TotalTime>
  <Words>130</Words>
  <Application>Microsoft Office PowerPoint</Application>
  <PresentationFormat>Personalizar</PresentationFormat>
  <Paragraphs>2</Paragraphs>
  <Slides>1</Slides>
  <Notes>0</Notes>
  <HiddenSlides>0</HiddenSlides>
  <MMClips>0</MMClips>
  <ScaleCrop>false</ScaleCrop>
  <HeadingPairs>
    <vt:vector size="8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Servidores OLE inseridos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o Office</vt:lpstr>
      <vt:lpstr>Prism 5</vt:lpstr>
      <vt:lpstr>Apresentação do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Leonardo Paiva Farias</dc:creator>
  <cp:lastModifiedBy>Leonardo Paiva Farias</cp:lastModifiedBy>
  <cp:revision>21</cp:revision>
  <dcterms:created xsi:type="dcterms:W3CDTF">2019-10-16T14:36:34Z</dcterms:created>
  <dcterms:modified xsi:type="dcterms:W3CDTF">2020-03-09T17:34:15Z</dcterms:modified>
</cp:coreProperties>
</file>